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1" r:id="rId3"/>
    <p:sldId id="264" r:id="rId4"/>
    <p:sldId id="265" r:id="rId5"/>
    <p:sldId id="267" r:id="rId6"/>
    <p:sldId id="263" r:id="rId7"/>
    <p:sldId id="266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69" autoAdjust="0"/>
    <p:restoredTop sz="94660"/>
  </p:normalViewPr>
  <p:slideViewPr>
    <p:cSldViewPr snapToGrid="0">
      <p:cViewPr>
        <p:scale>
          <a:sx n="141" d="100"/>
          <a:sy n="141" d="100"/>
        </p:scale>
        <p:origin x="-1368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B4266-3882-4AFD-A738-CA45A1FF0493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483B2-17E7-4069-936E-38F6027F6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16266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B4266-3882-4AFD-A738-CA45A1FF0493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483B2-17E7-4069-936E-38F6027F6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71998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B4266-3882-4AFD-A738-CA45A1FF0493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483B2-17E7-4069-936E-38F6027F6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44215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B4266-3882-4AFD-A738-CA45A1FF0493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483B2-17E7-4069-936E-38F6027F6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57700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B4266-3882-4AFD-A738-CA45A1FF0493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483B2-17E7-4069-936E-38F6027F6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16981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B4266-3882-4AFD-A738-CA45A1FF0493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483B2-17E7-4069-936E-38F6027F6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23978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B4266-3882-4AFD-A738-CA45A1FF0493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483B2-17E7-4069-936E-38F6027F6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9624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B4266-3882-4AFD-A738-CA45A1FF0493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483B2-17E7-4069-936E-38F6027F6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46764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B4266-3882-4AFD-A738-CA45A1FF0493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483B2-17E7-4069-936E-38F6027F6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43369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B4266-3882-4AFD-A738-CA45A1FF0493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483B2-17E7-4069-936E-38F6027F6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16191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CB4266-3882-4AFD-A738-CA45A1FF0493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483B2-17E7-4069-936E-38F6027F6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3353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CB4266-3882-4AFD-A738-CA45A1FF0493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E483B2-17E7-4069-936E-38F6027F6A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50531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2.xml"/><Relationship Id="rId4" Type="http://schemas.microsoft.com/office/2007/relationships/hdphoto" Target="../media/hdphoto1.wdp"/></Relationships>
</file>

<file path=ppt/slides/_rels/slide7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5" Type="http://schemas.microsoft.com/office/2007/relationships/hdphoto" Target="../media/hdphoto2.wdp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miR-184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Full membranes</a:t>
            </a:r>
          </a:p>
        </p:txBody>
      </p:sp>
    </p:spTree>
    <p:extLst>
      <p:ext uri="{BB962C8B-B14F-4D97-AF65-F5344CB8AC3E}">
        <p14:creationId xmlns:p14="http://schemas.microsoft.com/office/powerpoint/2010/main" val="17676726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62681" y="382374"/>
            <a:ext cx="8863913" cy="607583"/>
          </a:xfrm>
        </p:spPr>
        <p:txBody>
          <a:bodyPr>
            <a:normAutofit/>
          </a:bodyPr>
          <a:lstStyle/>
          <a:p>
            <a:r>
              <a:rPr lang="en-US" sz="3200" b="1" dirty="0">
                <a:latin typeface="Arial Black" panose="020B0A04020102020204" pitchFamily="34" charset="0"/>
              </a:rPr>
              <a:t>WB for b-catenin in TPA-DMBA Tumors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2314" y="1894703"/>
            <a:ext cx="3183859" cy="60959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/>
          <p:cNvSpPr txBox="1"/>
          <p:nvPr/>
        </p:nvSpPr>
        <p:spPr>
          <a:xfrm>
            <a:off x="2372497" y="2014836"/>
            <a:ext cx="13262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Symbol" panose="05050102010706020507" pitchFamily="18" charset="2"/>
              </a:rPr>
              <a:t>B</a:t>
            </a:r>
            <a:r>
              <a:rPr lang="en-US" dirty="0"/>
              <a:t>-catenin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9712411" y="5832389"/>
            <a:ext cx="24795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% acrylamide Gel</a:t>
            </a: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2314" y="2726965"/>
            <a:ext cx="3183859" cy="47990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TextBox 12"/>
          <p:cNvSpPr txBox="1"/>
          <p:nvPr/>
        </p:nvSpPr>
        <p:spPr>
          <a:xfrm>
            <a:off x="2545214" y="2813533"/>
            <a:ext cx="13308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698789" y="1295708"/>
            <a:ext cx="5627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KO WB II B-2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501535" y="1285581"/>
            <a:ext cx="5627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WT WB I B-1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5297500" y="1295708"/>
            <a:ext cx="5627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KO WB II B-2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5976836" y="1295708"/>
            <a:ext cx="5627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WT WB I B-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F51A5EC-5917-4777-B924-B990CE3C8E1E}"/>
              </a:ext>
            </a:extLst>
          </p:cNvPr>
          <p:cNvSpPr txBox="1"/>
          <p:nvPr/>
        </p:nvSpPr>
        <p:spPr>
          <a:xfrm>
            <a:off x="10055311" y="501499"/>
            <a:ext cx="896894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>
                <a:highlight>
                  <a:srgbClr val="FFFF00"/>
                </a:highlight>
              </a:rPr>
              <a:t>Fig 5.A</a:t>
            </a:r>
            <a:endParaRPr lang="he-IL" dirty="0">
              <a:highlight>
                <a:srgbClr val="FFFF00"/>
              </a:highlight>
            </a:endParaRPr>
          </a:p>
        </p:txBody>
      </p:sp>
    </p:spTree>
    <p:extLst>
      <p:ext uri="{BB962C8B-B14F-4D97-AF65-F5344CB8AC3E}">
        <p14:creationId xmlns:p14="http://schemas.microsoft.com/office/powerpoint/2010/main" val="27639457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62681" y="382374"/>
            <a:ext cx="8863913" cy="607583"/>
          </a:xfrm>
        </p:spPr>
        <p:txBody>
          <a:bodyPr>
            <a:normAutofit/>
          </a:bodyPr>
          <a:lstStyle/>
          <a:p>
            <a:r>
              <a:rPr lang="en-US" sz="3200" b="1" dirty="0">
                <a:latin typeface="Arial Black" panose="020B0A04020102020204" pitchFamily="34" charset="0"/>
              </a:rPr>
              <a:t>WB for b-catenin in TPA-DMBA Tumor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9712411" y="5832389"/>
            <a:ext cx="24795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% acrylamide Gel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F51A5EC-5917-4777-B924-B990CE3C8E1E}"/>
              </a:ext>
            </a:extLst>
          </p:cNvPr>
          <p:cNvSpPr txBox="1"/>
          <p:nvPr/>
        </p:nvSpPr>
        <p:spPr>
          <a:xfrm>
            <a:off x="10055311" y="501499"/>
            <a:ext cx="896894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>
                <a:highlight>
                  <a:srgbClr val="FFFF00"/>
                </a:highlight>
              </a:rPr>
              <a:t>Fig 5.A</a:t>
            </a:r>
            <a:endParaRPr lang="he-IL" dirty="0">
              <a:highlight>
                <a:srgbClr val="FFFF00"/>
              </a:highlight>
            </a:endParaRP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F62E8E9E-E6C3-84FF-0BB4-3D97CB92BB4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26" t="9362" r="29291" b="24088"/>
          <a:stretch/>
        </p:blipFill>
        <p:spPr>
          <a:xfrm>
            <a:off x="655198" y="1773609"/>
            <a:ext cx="4950265" cy="3826586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D49307FE-BEF6-199A-FEAF-896FF82F92A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618" r="33235" b="49912"/>
          <a:stretch/>
        </p:blipFill>
        <p:spPr>
          <a:xfrm>
            <a:off x="6586537" y="1773609"/>
            <a:ext cx="4950265" cy="38265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538875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376646" y="386831"/>
            <a:ext cx="9922933" cy="456142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67500" lnSpcReduction="2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dirty="0"/>
              <a:t>WB for skin SCC infected cell line 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2548468" y="1628801"/>
            <a:ext cx="1371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Symbol" panose="05050102010706020507" pitchFamily="18" charset="2"/>
                <a:ea typeface="Arial Unicode MS" panose="020B0604020202020204" pitchFamily="34" charset="-128"/>
                <a:cs typeface="Arial Unicode MS" panose="020B0604020202020204" pitchFamily="34" charset="-128"/>
              </a:rPr>
              <a:t>b</a:t>
            </a:r>
            <a:r>
              <a:rPr lang="en-US" dirty="0"/>
              <a:t>- cat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530600" y="1406051"/>
            <a:ext cx="5672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Control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637536" y="1406051"/>
            <a:ext cx="5672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Control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652438" y="1406051"/>
            <a:ext cx="5672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Control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170856" y="1406051"/>
            <a:ext cx="4380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AM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239684" y="1406051"/>
            <a:ext cx="4380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AM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6289087" y="1406051"/>
            <a:ext cx="4380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AM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6719991" y="1406051"/>
            <a:ext cx="14816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GFP</a:t>
            </a:r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3530600" y="1413485"/>
            <a:ext cx="982133" cy="0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4608925" y="1413485"/>
            <a:ext cx="982133" cy="0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>
            <a:off x="5652438" y="1413485"/>
            <a:ext cx="982133" cy="0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3779520" y="1211643"/>
            <a:ext cx="9990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4.7.19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4798743" y="1211643"/>
            <a:ext cx="9990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0.8.19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5836398" y="1211643"/>
            <a:ext cx="9990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.9.19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2519857" y="2220883"/>
            <a:ext cx="889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</a:t>
            </a:r>
          </a:p>
        </p:txBody>
      </p:sp>
      <p:pic>
        <p:nvPicPr>
          <p:cNvPr id="30" name="Picture 2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2848" y="1673179"/>
            <a:ext cx="3675398" cy="31751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3" name="Picture 3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4237" y="2223268"/>
            <a:ext cx="3732619" cy="36456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66470095-7686-4902-97A3-460278287D4B}"/>
              </a:ext>
            </a:extLst>
          </p:cNvPr>
          <p:cNvSpPr/>
          <p:nvPr/>
        </p:nvSpPr>
        <p:spPr>
          <a:xfrm>
            <a:off x="8201657" y="384892"/>
            <a:ext cx="873957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dirty="0">
                <a:highlight>
                  <a:srgbClr val="FFFF00"/>
                </a:highlight>
              </a:rPr>
              <a:t>Fig 5.B</a:t>
            </a:r>
            <a:endParaRPr lang="he-IL" sz="2000" dirty="0">
              <a:highlight>
                <a:srgbClr val="FFFF00"/>
              </a:highlight>
            </a:endParaRPr>
          </a:p>
        </p:txBody>
      </p:sp>
    </p:spTree>
    <p:extLst>
      <p:ext uri="{BB962C8B-B14F-4D97-AF65-F5344CB8AC3E}">
        <p14:creationId xmlns:p14="http://schemas.microsoft.com/office/powerpoint/2010/main" val="3376858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376646" y="386831"/>
            <a:ext cx="9922933" cy="456142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67500" lnSpcReduction="2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dirty="0"/>
              <a:t>WB for skin SCC infected cell line 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66470095-7686-4902-97A3-460278287D4B}"/>
              </a:ext>
            </a:extLst>
          </p:cNvPr>
          <p:cNvSpPr/>
          <p:nvPr/>
        </p:nvSpPr>
        <p:spPr>
          <a:xfrm>
            <a:off x="8201657" y="384892"/>
            <a:ext cx="873957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dirty="0">
                <a:highlight>
                  <a:srgbClr val="FFFF00"/>
                </a:highlight>
              </a:rPr>
              <a:t>Fig 5.B</a:t>
            </a:r>
            <a:endParaRPr lang="he-IL" sz="2000" dirty="0">
              <a:highlight>
                <a:srgbClr val="FFFF00"/>
              </a:highlight>
            </a:endParaRPr>
          </a:p>
        </p:txBody>
      </p:sp>
      <p:pic>
        <p:nvPicPr>
          <p:cNvPr id="2" name="Picture 1" descr="A close-up of a white rectangular object&#10;&#10;Description automatically generated">
            <a:extLst>
              <a:ext uri="{FF2B5EF4-FFF2-40B4-BE49-F238E27FC236}">
                <a16:creationId xmlns:a16="http://schemas.microsoft.com/office/drawing/2014/main" id="{F5049143-E379-A1CC-3E5C-2180DA297A3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00" t="8481" r="18826" b="31948"/>
          <a:stretch/>
        </p:blipFill>
        <p:spPr>
          <a:xfrm>
            <a:off x="993140" y="2029522"/>
            <a:ext cx="4701666" cy="2999678"/>
          </a:xfrm>
          <a:prstGeom prst="rect">
            <a:avLst/>
          </a:prstGeom>
        </p:spPr>
      </p:pic>
      <p:pic>
        <p:nvPicPr>
          <p:cNvPr id="14" name="Picture 13" descr="A close-up of a test tube&#10;&#10;Description automatically generated">
            <a:extLst>
              <a:ext uri="{FF2B5EF4-FFF2-40B4-BE49-F238E27FC236}">
                <a16:creationId xmlns:a16="http://schemas.microsoft.com/office/drawing/2014/main" id="{B7987E7F-8477-3BE1-5B67-1BE40634BE3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09" r="12749" b="32480"/>
          <a:stretch/>
        </p:blipFill>
        <p:spPr>
          <a:xfrm>
            <a:off x="6407985" y="2029522"/>
            <a:ext cx="5006229" cy="29996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598037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09205" y="186948"/>
            <a:ext cx="8893524" cy="679936"/>
          </a:xfrm>
        </p:spPr>
        <p:txBody>
          <a:bodyPr>
            <a:normAutofit fontScale="90000"/>
          </a:bodyPr>
          <a:lstStyle/>
          <a:p>
            <a:r>
              <a:rPr lang="en-US" dirty="0"/>
              <a:t>WB for NOD/SCID tumors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087135" y="1712679"/>
            <a:ext cx="7150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Symbol" panose="05050102010706020507" pitchFamily="18" charset="2"/>
                <a:ea typeface="Arial Unicode MS" panose="020B0604020202020204" pitchFamily="34" charset="-128"/>
                <a:cs typeface="Arial Unicode MS" panose="020B0604020202020204" pitchFamily="34" charset="-128"/>
              </a:rPr>
              <a:t>b</a:t>
            </a:r>
            <a:r>
              <a:rPr lang="en-US" dirty="0"/>
              <a:t>- cat 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9716071" y="5701242"/>
            <a:ext cx="3386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% gel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02171" y="1284762"/>
            <a:ext cx="5503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Ctrl NN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198630" y="1284762"/>
            <a:ext cx="5503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Ctrl</a:t>
            </a:r>
          </a:p>
          <a:p>
            <a:r>
              <a:rPr lang="en-US" sz="1000" dirty="0"/>
              <a:t>RN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564298" y="1284762"/>
            <a:ext cx="5503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AM</a:t>
            </a:r>
          </a:p>
          <a:p>
            <a:r>
              <a:rPr lang="en-US" sz="1000" dirty="0"/>
              <a:t>2RN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977686" y="1284762"/>
            <a:ext cx="5503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AM</a:t>
            </a:r>
          </a:p>
          <a:p>
            <a:r>
              <a:rPr lang="en-US" sz="1000" dirty="0"/>
              <a:t>RN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356605" y="1284762"/>
            <a:ext cx="5503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Ctrl cells</a:t>
            </a:r>
          </a:p>
        </p:txBody>
      </p:sp>
      <p:cxnSp>
        <p:nvCxnSpPr>
          <p:cNvPr id="19" name="Straight Arrow Connector 18"/>
          <p:cNvCxnSpPr>
            <a:endCxn id="11" idx="0"/>
          </p:cNvCxnSpPr>
          <p:nvPr/>
        </p:nvCxnSpPr>
        <p:spPr>
          <a:xfrm>
            <a:off x="3756906" y="1284725"/>
            <a:ext cx="1874866" cy="37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4101817" y="947759"/>
            <a:ext cx="14506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CC Tumors         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787516" y="2349130"/>
            <a:ext cx="889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</a:t>
            </a:r>
          </a:p>
        </p:txBody>
      </p:sp>
      <p:pic>
        <p:nvPicPr>
          <p:cNvPr id="29" name="תמונה 28" descr="תמונה שמכילה בגדים, אדם&#10;&#10;התיאור נוצר באופן אוטומטי">
            <a:extLst>
              <a:ext uri="{FF2B5EF4-FFF2-40B4-BE49-F238E27FC236}">
                <a16:creationId xmlns:a16="http://schemas.microsoft.com/office/drawing/2014/main" id="{1CDD27A8-B0CF-435E-9673-265E442D818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6772" y="2353297"/>
            <a:ext cx="1823785" cy="3547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80E6B15D-EE2C-41FB-A5F6-ECAA8E42EB3B}"/>
              </a:ext>
            </a:extLst>
          </p:cNvPr>
          <p:cNvSpPr/>
          <p:nvPr/>
        </p:nvSpPr>
        <p:spPr>
          <a:xfrm>
            <a:off x="7735071" y="353324"/>
            <a:ext cx="923714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dirty="0">
                <a:highlight>
                  <a:srgbClr val="FFFF00"/>
                </a:highlight>
              </a:rPr>
              <a:t>Fig 5.C </a:t>
            </a:r>
            <a:endParaRPr lang="he-IL" sz="2000" dirty="0">
              <a:highlight>
                <a:srgbClr val="FFFF00"/>
              </a:highlight>
            </a:endParaRPr>
          </a:p>
        </p:txBody>
      </p:sp>
      <p:pic>
        <p:nvPicPr>
          <p:cNvPr id="34" name="תמונה 30" descr="תמונה שמכילה צילום, לבן, איש, ישיבה&#10;&#10;התיאור נוצר באופן אוטומטי">
            <a:extLst>
              <a:ext uri="{FF2B5EF4-FFF2-40B4-BE49-F238E27FC236}">
                <a16:creationId xmlns:a16="http://schemas.microsoft.com/office/drawing/2014/main" id="{3955E6A4-3BA8-F844-9251-B0E578BB7DA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alphaModFix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933" t="29115" r="54420" b="60350"/>
          <a:stretch/>
        </p:blipFill>
        <p:spPr>
          <a:xfrm>
            <a:off x="3876771" y="1692360"/>
            <a:ext cx="1823785" cy="567908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80920293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09205" y="186948"/>
            <a:ext cx="8893524" cy="679936"/>
          </a:xfrm>
        </p:spPr>
        <p:txBody>
          <a:bodyPr>
            <a:normAutofit fontScale="90000"/>
          </a:bodyPr>
          <a:lstStyle/>
          <a:p>
            <a:r>
              <a:rPr lang="en-US" dirty="0"/>
              <a:t>WB for NOD/SCID tumors </a:t>
            </a:r>
          </a:p>
        </p:txBody>
      </p:sp>
      <p:pic>
        <p:nvPicPr>
          <p:cNvPr id="31" name="תמונה 30" descr="תמונה שמכילה צילום, לבן, איש, ישיבה&#10;&#10;התיאור נוצר באופן אוטומטי">
            <a:extLst>
              <a:ext uri="{FF2B5EF4-FFF2-40B4-BE49-F238E27FC236}">
                <a16:creationId xmlns:a16="http://schemas.microsoft.com/office/drawing/2014/main" id="{0F109250-19E2-412B-9312-B21AE9163D8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alphaModFix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236" t="6588" r="26972" b="34342"/>
          <a:stretch/>
        </p:blipFill>
        <p:spPr>
          <a:xfrm>
            <a:off x="246591" y="1138644"/>
            <a:ext cx="5788770" cy="3812498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80E6B15D-EE2C-41FB-A5F6-ECAA8E42EB3B}"/>
              </a:ext>
            </a:extLst>
          </p:cNvPr>
          <p:cNvSpPr/>
          <p:nvPr/>
        </p:nvSpPr>
        <p:spPr>
          <a:xfrm>
            <a:off x="7735071" y="353324"/>
            <a:ext cx="923714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dirty="0">
                <a:highlight>
                  <a:srgbClr val="FFFF00"/>
                </a:highlight>
              </a:rPr>
              <a:t>Fig 5.C </a:t>
            </a:r>
            <a:endParaRPr lang="he-IL" sz="2000" dirty="0">
              <a:highlight>
                <a:srgbClr val="FFFF00"/>
              </a:highlight>
            </a:endParaRPr>
          </a:p>
        </p:txBody>
      </p:sp>
      <p:pic>
        <p:nvPicPr>
          <p:cNvPr id="4" name="Picture 3" descr="A black lines on a white background&#10;&#10;Description automatically generated">
            <a:extLst>
              <a:ext uri="{FF2B5EF4-FFF2-40B4-BE49-F238E27FC236}">
                <a16:creationId xmlns:a16="http://schemas.microsoft.com/office/drawing/2014/main" id="{DFA0A0CA-87E6-FDE5-6084-61BB6187064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35361" y="1301378"/>
            <a:ext cx="5466078" cy="36497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396195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08</TotalTime>
  <Words>122</Words>
  <Application>Microsoft Macintosh PowerPoint</Application>
  <PresentationFormat>Widescreen</PresentationFormat>
  <Paragraphs>46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rial</vt:lpstr>
      <vt:lpstr>Arial Black</vt:lpstr>
      <vt:lpstr>Calibri</vt:lpstr>
      <vt:lpstr>Calibri Light</vt:lpstr>
      <vt:lpstr>Symbol</vt:lpstr>
      <vt:lpstr>Office Theme</vt:lpstr>
      <vt:lpstr>miR-184</vt:lpstr>
      <vt:lpstr>WB for b-catenin in TPA-DMBA Tumors</vt:lpstr>
      <vt:lpstr>WB for b-catenin in TPA-DMBA Tumors</vt:lpstr>
      <vt:lpstr>PowerPoint Presentation</vt:lpstr>
      <vt:lpstr>PowerPoint Presentation</vt:lpstr>
      <vt:lpstr>WB for NOD/SCID tumors </vt:lpstr>
      <vt:lpstr>WB for NOD/SCID tumors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iR-184</dc:title>
  <dc:creator>RubiLab</dc:creator>
  <cp:lastModifiedBy>Emily Avitan</cp:lastModifiedBy>
  <cp:revision>45</cp:revision>
  <dcterms:created xsi:type="dcterms:W3CDTF">2020-01-29T13:27:19Z</dcterms:created>
  <dcterms:modified xsi:type="dcterms:W3CDTF">2023-11-14T20:31:23Z</dcterms:modified>
</cp:coreProperties>
</file>